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327" r:id="rId2"/>
    <p:sldId id="331" r:id="rId3"/>
  </p:sldIdLst>
  <p:sldSz cx="7772400" cy="10058400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egura, Jason (NIH/NIAID) [F]" initials="SJ([" lastIdx="1" clrIdx="0">
    <p:extLst>
      <p:ext uri="{19B8F6BF-5375-455C-9EA6-DF929625EA0E}">
        <p15:presenceInfo xmlns:p15="http://schemas.microsoft.com/office/powerpoint/2012/main" userId="S::segurajm@nih.gov::9b1b00a5-cc17-4204-89f3-061b6febed7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A01BF"/>
    <a:srgbClr val="03E2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62" autoAdjust="0"/>
    <p:restoredTop sz="96357" autoAdjust="0"/>
  </p:normalViewPr>
  <p:slideViewPr>
    <p:cSldViewPr snapToGrid="0">
      <p:cViewPr varScale="1">
        <p:scale>
          <a:sx n="78" d="100"/>
          <a:sy n="78" d="100"/>
        </p:scale>
        <p:origin x="305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475" cy="481045"/>
          </a:xfrm>
          <a:prstGeom prst="rect">
            <a:avLst/>
          </a:prstGeom>
        </p:spPr>
        <p:txBody>
          <a:bodyPr vert="horz" lIns="95069" tIns="47534" rIns="95069" bIns="4753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064" y="0"/>
            <a:ext cx="3170475" cy="481045"/>
          </a:xfrm>
          <a:prstGeom prst="rect">
            <a:avLst/>
          </a:prstGeom>
        </p:spPr>
        <p:txBody>
          <a:bodyPr vert="horz" lIns="95069" tIns="47534" rIns="95069" bIns="47534" rtlCol="0"/>
          <a:lstStyle>
            <a:lvl1pPr algn="r">
              <a:defRPr sz="1200"/>
            </a:lvl1pPr>
          </a:lstStyle>
          <a:p>
            <a:fld id="{AC15AEC4-8305-46B6-B820-9070F90C275D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5063" y="1200150"/>
            <a:ext cx="2505075" cy="3241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069" tIns="47534" rIns="95069" bIns="4753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004"/>
            <a:ext cx="5852160" cy="3781047"/>
          </a:xfrm>
          <a:prstGeom prst="rect">
            <a:avLst/>
          </a:prstGeom>
        </p:spPr>
        <p:txBody>
          <a:bodyPr vert="horz" lIns="95069" tIns="47534" rIns="95069" bIns="47534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56"/>
            <a:ext cx="3170475" cy="481044"/>
          </a:xfrm>
          <a:prstGeom prst="rect">
            <a:avLst/>
          </a:prstGeom>
        </p:spPr>
        <p:txBody>
          <a:bodyPr vert="horz" lIns="95069" tIns="47534" rIns="95069" bIns="4753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064" y="9120156"/>
            <a:ext cx="3170475" cy="481044"/>
          </a:xfrm>
          <a:prstGeom prst="rect">
            <a:avLst/>
          </a:prstGeom>
        </p:spPr>
        <p:txBody>
          <a:bodyPr vert="horz" lIns="95069" tIns="47534" rIns="95069" bIns="47534" rtlCol="0" anchor="b"/>
          <a:lstStyle>
            <a:lvl1pPr algn="r">
              <a:defRPr sz="1200"/>
            </a:lvl1pPr>
          </a:lstStyle>
          <a:p>
            <a:fld id="{06BD53CA-9DAD-47B5-89E1-B7E105B0A6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862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942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21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186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973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520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507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7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867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857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685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605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95F23-18C9-4FDD-B977-A9478D2B8669}" type="datetimeFigureOut">
              <a:rPr lang="en-US" smtClean="0"/>
              <a:t>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73FA91-113B-4BC5-8528-47FE1A203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249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5.jpeg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5A872B34-DC6A-4646-86C0-BBBD39F09CC4}"/>
              </a:ext>
            </a:extLst>
          </p:cNvPr>
          <p:cNvSpPr txBox="1"/>
          <p:nvPr/>
        </p:nvSpPr>
        <p:spPr>
          <a:xfrm>
            <a:off x="114302" y="51576"/>
            <a:ext cx="26874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43776"/>
            <a:r>
              <a:rPr lang="en-US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ECDF6A3-46FD-48B6-8C26-A85E91D8F49C}"/>
              </a:ext>
            </a:extLst>
          </p:cNvPr>
          <p:cNvSpPr txBox="1"/>
          <p:nvPr/>
        </p:nvSpPr>
        <p:spPr>
          <a:xfrm>
            <a:off x="433931" y="427917"/>
            <a:ext cx="174249" cy="361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887554"/>
            <a:r>
              <a:rPr lang="en-US" sz="1747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4271497-D5DF-4341-A264-BB40F061971C}"/>
              </a:ext>
            </a:extLst>
          </p:cNvPr>
          <p:cNvSpPr txBox="1"/>
          <p:nvPr/>
        </p:nvSpPr>
        <p:spPr>
          <a:xfrm>
            <a:off x="433932" y="3499270"/>
            <a:ext cx="174249" cy="361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887554"/>
            <a:r>
              <a:rPr lang="en-US" sz="1747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AA7BEBCD-360F-4373-B016-DA243BE22EB2}"/>
              </a:ext>
            </a:extLst>
          </p:cNvPr>
          <p:cNvGrpSpPr/>
          <p:nvPr/>
        </p:nvGrpSpPr>
        <p:grpSpPr>
          <a:xfrm>
            <a:off x="657508" y="804259"/>
            <a:ext cx="2526894" cy="2573260"/>
            <a:chOff x="1084388" y="372806"/>
            <a:chExt cx="2933707" cy="2891008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F62A29F2-82A7-450C-9A26-8F66678007D2}"/>
                </a:ext>
              </a:extLst>
            </p:cNvPr>
            <p:cNvGrpSpPr/>
            <p:nvPr/>
          </p:nvGrpSpPr>
          <p:grpSpPr>
            <a:xfrm>
              <a:off x="1084388" y="828216"/>
              <a:ext cx="2906149" cy="2435598"/>
              <a:chOff x="1306175" y="739649"/>
              <a:chExt cx="3499224" cy="3125591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02B3C742-3AB8-4917-A7EC-494A06B502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702" t="6120" r="12953" b="41245"/>
              <a:stretch/>
            </p:blipFill>
            <p:spPr>
              <a:xfrm>
                <a:off x="1306175" y="739649"/>
                <a:ext cx="3499224" cy="3125591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CA7A1DC7-331E-457F-9C38-F8623E4E6D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93918" y="888955"/>
                <a:ext cx="27432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31B4703-6D6C-4EDE-8302-CE89E7901C3C}"/>
                </a:ext>
              </a:extLst>
            </p:cNvPr>
            <p:cNvSpPr txBox="1"/>
            <p:nvPr/>
          </p:nvSpPr>
          <p:spPr>
            <a:xfrm>
              <a:off x="1194768" y="372806"/>
              <a:ext cx="2823327" cy="4057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43776"/>
              <a:r>
                <a:rPr lang="en-US" sz="1747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V-1</a:t>
              </a:r>
              <a:r>
                <a:rPr lang="en-US" sz="1747" baseline="-25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AL </a:t>
              </a:r>
              <a:r>
                <a:rPr lang="en-US" sz="1747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Belnacasan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FE425E85-FDB6-44CC-AF1E-CEB10AFD4229}"/>
              </a:ext>
            </a:extLst>
          </p:cNvPr>
          <p:cNvSpPr txBox="1"/>
          <p:nvPr/>
        </p:nvSpPr>
        <p:spPr>
          <a:xfrm>
            <a:off x="2870438" y="3499269"/>
            <a:ext cx="174249" cy="361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887554"/>
            <a:r>
              <a:rPr lang="en-US" sz="1747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4B72074-73C5-4E69-9D1C-91B729A208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7643145"/>
              </p:ext>
            </p:extLst>
          </p:nvPr>
        </p:nvGraphicFramePr>
        <p:xfrm>
          <a:off x="2844999" y="3798092"/>
          <a:ext cx="1859757" cy="28597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66" name="Prism 8" r:id="rId4" imgW="1916282" imgH="2945700" progId="Prism8.Document">
                  <p:embed/>
                </p:oleObj>
              </mc:Choice>
              <mc:Fallback>
                <p:oleObj name="Prism 8" r:id="rId4" imgW="1916282" imgH="2945700" progId="Prism8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74B72074-73C5-4E69-9D1C-91B729A208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44999" y="3798092"/>
                        <a:ext cx="1859757" cy="28597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42488EE0-4A4E-4EFD-AA34-1A8C7DBB14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1135046"/>
              </p:ext>
            </p:extLst>
          </p:nvPr>
        </p:nvGraphicFramePr>
        <p:xfrm>
          <a:off x="676613" y="3809753"/>
          <a:ext cx="1855134" cy="28597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67" name="Prism 8" r:id="rId6" imgW="1911961" imgH="2945700" progId="Prism8.Document">
                  <p:embed/>
                </p:oleObj>
              </mc:Choice>
              <mc:Fallback>
                <p:oleObj name="Prism 8" r:id="rId6" imgW="1911961" imgH="2945700" progId="Prism8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42488EE0-4A4E-4EFD-AA34-1A8C7DBB14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76613" y="3809753"/>
                        <a:ext cx="1855134" cy="28597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5" name="TextBox 44">
            <a:extLst>
              <a:ext uri="{FF2B5EF4-FFF2-40B4-BE49-F238E27FC236}">
                <a16:creationId xmlns:a16="http://schemas.microsoft.com/office/drawing/2014/main" id="{8AB750E5-2E8C-4F93-BB65-C516FCC3D4F4}"/>
              </a:ext>
            </a:extLst>
          </p:cNvPr>
          <p:cNvSpPr txBox="1"/>
          <p:nvPr/>
        </p:nvSpPr>
        <p:spPr>
          <a:xfrm>
            <a:off x="475352" y="6570623"/>
            <a:ext cx="174249" cy="361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887554"/>
            <a:r>
              <a:rPr lang="en-US" sz="1747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CBD6A6E-464E-47BA-BF8A-A80F1A6629DD}"/>
              </a:ext>
            </a:extLst>
          </p:cNvPr>
          <p:cNvSpPr txBox="1"/>
          <p:nvPr/>
        </p:nvSpPr>
        <p:spPr>
          <a:xfrm>
            <a:off x="3503806" y="380999"/>
            <a:ext cx="174249" cy="361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887554"/>
            <a:r>
              <a:rPr lang="en-US" sz="1747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589B3F2A-92BA-4605-BE98-2E9647EBE86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75922" y="1007672"/>
          <a:ext cx="1820900" cy="2324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68" name="Prism 8" r:id="rId8" imgW="2765482" imgH="3529510" progId="Prism8.Document">
                  <p:embed/>
                </p:oleObj>
              </mc:Choice>
              <mc:Fallback>
                <p:oleObj name="Prism 8" r:id="rId8" imgW="2765482" imgH="3529510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589B3F2A-92BA-4605-BE98-2E9647EBE8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75922" y="1007672"/>
                        <a:ext cx="1820900" cy="2324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307322E-EE35-4F22-8510-D21C7949C9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7028503"/>
              </p:ext>
            </p:extLst>
          </p:nvPr>
        </p:nvGraphicFramePr>
        <p:xfrm>
          <a:off x="5538709" y="206455"/>
          <a:ext cx="1503829" cy="3507200"/>
        </p:xfrm>
        <a:graphic>
          <a:graphicData uri="http://schemas.openxmlformats.org/drawingml/2006/table">
            <a:tbl>
              <a:tblPr/>
              <a:tblGrid>
                <a:gridCol w="304456">
                  <a:extLst>
                    <a:ext uri="{9D8B030D-6E8A-4147-A177-3AD203B41FA5}">
                      <a16:colId xmlns:a16="http://schemas.microsoft.com/office/drawing/2014/main" val="2961364159"/>
                    </a:ext>
                  </a:extLst>
                </a:gridCol>
                <a:gridCol w="498201">
                  <a:extLst>
                    <a:ext uri="{9D8B030D-6E8A-4147-A177-3AD203B41FA5}">
                      <a16:colId xmlns:a16="http://schemas.microsoft.com/office/drawing/2014/main" val="1807103771"/>
                    </a:ext>
                  </a:extLst>
                </a:gridCol>
                <a:gridCol w="175293">
                  <a:extLst>
                    <a:ext uri="{9D8B030D-6E8A-4147-A177-3AD203B41FA5}">
                      <a16:colId xmlns:a16="http://schemas.microsoft.com/office/drawing/2014/main" val="975135062"/>
                    </a:ext>
                  </a:extLst>
                </a:gridCol>
                <a:gridCol w="175293">
                  <a:extLst>
                    <a:ext uri="{9D8B030D-6E8A-4147-A177-3AD203B41FA5}">
                      <a16:colId xmlns:a16="http://schemas.microsoft.com/office/drawing/2014/main" val="4088000"/>
                    </a:ext>
                  </a:extLst>
                </a:gridCol>
                <a:gridCol w="175293">
                  <a:extLst>
                    <a:ext uri="{9D8B030D-6E8A-4147-A177-3AD203B41FA5}">
                      <a16:colId xmlns:a16="http://schemas.microsoft.com/office/drawing/2014/main" val="242269687"/>
                    </a:ext>
                  </a:extLst>
                </a:gridCol>
                <a:gridCol w="175293">
                  <a:extLst>
                    <a:ext uri="{9D8B030D-6E8A-4147-A177-3AD203B41FA5}">
                      <a16:colId xmlns:a16="http://schemas.microsoft.com/office/drawing/2014/main" val="1662795394"/>
                    </a:ext>
                  </a:extLst>
                </a:gridCol>
              </a:tblGrid>
              <a:tr h="160120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= 0.9278 </a:t>
                      </a:r>
                    </a:p>
                  </a:txBody>
                  <a:tcPr marL="9244" marR="9244" marT="92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65696492"/>
                  </a:ext>
                </a:extLst>
              </a:tr>
              <a:tr h="16012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f+</a:t>
                      </a:r>
                    </a:p>
                  </a:txBody>
                  <a:tcPr marL="9244" marR="9244" marT="92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f-</a:t>
                      </a:r>
                    </a:p>
                  </a:txBody>
                  <a:tcPr marL="9244" marR="9244" marT="92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6870065"/>
                  </a:ext>
                </a:extLst>
              </a:tr>
              <a:tr h="176884">
                <a:tc rowSpan="18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LR signaling pathway</a:t>
                      </a:r>
                    </a:p>
                  </a:txBody>
                  <a:tcPr marL="9244" marR="9244" marT="9244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YD88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A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9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FD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9415985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RAK1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9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9817086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RAK4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D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5269581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IF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D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7696500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F3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D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BE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5352113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F6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E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D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239985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K1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D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0E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5946890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1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C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6314966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B2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B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9959401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KK3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BE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E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1536663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KK6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D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5B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D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B6B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1346152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NK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E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DFD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7816795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RK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9757872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F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D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4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3416916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KK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E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CF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1380105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KKb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7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8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25407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KKe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9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6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6812891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MO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B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D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1883607"/>
                  </a:ext>
                </a:extLst>
              </a:tr>
            </a:tbl>
          </a:graphicData>
        </a:graphic>
      </p:graphicFrame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57A9D2F3-1503-449B-927F-3843050D97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9192817"/>
              </p:ext>
            </p:extLst>
          </p:nvPr>
        </p:nvGraphicFramePr>
        <p:xfrm>
          <a:off x="5538709" y="3825752"/>
          <a:ext cx="1503829" cy="2976548"/>
        </p:xfrm>
        <a:graphic>
          <a:graphicData uri="http://schemas.openxmlformats.org/drawingml/2006/table">
            <a:tbl>
              <a:tblPr/>
              <a:tblGrid>
                <a:gridCol w="304456">
                  <a:extLst>
                    <a:ext uri="{9D8B030D-6E8A-4147-A177-3AD203B41FA5}">
                      <a16:colId xmlns:a16="http://schemas.microsoft.com/office/drawing/2014/main" val="2989639363"/>
                    </a:ext>
                  </a:extLst>
                </a:gridCol>
                <a:gridCol w="498201">
                  <a:extLst>
                    <a:ext uri="{9D8B030D-6E8A-4147-A177-3AD203B41FA5}">
                      <a16:colId xmlns:a16="http://schemas.microsoft.com/office/drawing/2014/main" val="3476453894"/>
                    </a:ext>
                  </a:extLst>
                </a:gridCol>
                <a:gridCol w="175293">
                  <a:extLst>
                    <a:ext uri="{9D8B030D-6E8A-4147-A177-3AD203B41FA5}">
                      <a16:colId xmlns:a16="http://schemas.microsoft.com/office/drawing/2014/main" val="3216771288"/>
                    </a:ext>
                  </a:extLst>
                </a:gridCol>
                <a:gridCol w="175293">
                  <a:extLst>
                    <a:ext uri="{9D8B030D-6E8A-4147-A177-3AD203B41FA5}">
                      <a16:colId xmlns:a16="http://schemas.microsoft.com/office/drawing/2014/main" val="55667959"/>
                    </a:ext>
                  </a:extLst>
                </a:gridCol>
                <a:gridCol w="175293">
                  <a:extLst>
                    <a:ext uri="{9D8B030D-6E8A-4147-A177-3AD203B41FA5}">
                      <a16:colId xmlns:a16="http://schemas.microsoft.com/office/drawing/2014/main" val="1252591552"/>
                    </a:ext>
                  </a:extLst>
                </a:gridCol>
                <a:gridCol w="175293">
                  <a:extLst>
                    <a:ext uri="{9D8B030D-6E8A-4147-A177-3AD203B41FA5}">
                      <a16:colId xmlns:a16="http://schemas.microsoft.com/office/drawing/2014/main" val="619380457"/>
                    </a:ext>
                  </a:extLst>
                </a:gridCol>
              </a:tblGrid>
              <a:tr h="160120"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= 0.1736</a:t>
                      </a:r>
                    </a:p>
                  </a:txBody>
                  <a:tcPr marL="9244" marR="9244" marT="92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7910859"/>
                  </a:ext>
                </a:extLst>
              </a:tr>
              <a:tr h="160120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9244" marR="9244" marT="92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f+</a:t>
                      </a:r>
                    </a:p>
                  </a:txBody>
                  <a:tcPr marL="9244" marR="9244" marT="92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f-</a:t>
                      </a:r>
                    </a:p>
                  </a:txBody>
                  <a:tcPr marL="9244" marR="9244" marT="92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30966468"/>
                  </a:ext>
                </a:extLst>
              </a:tr>
              <a:tr h="176884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L-2 signaling pathway</a:t>
                      </a:r>
                    </a:p>
                  </a:txBody>
                  <a:tcPr marL="9244" marR="9244" marT="9244" marB="0" vert="vert27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1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D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6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B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4314838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JAK3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0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D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CF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0085835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1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D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67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575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0202194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3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3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2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4596303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5A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C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BEB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7489217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T5B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E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9695622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B2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7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8005269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S-1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2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BC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1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ACA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9124266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S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1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C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5C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4286040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F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F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4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E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3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4951967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K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8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9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4015277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RK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5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3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4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0337322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I3K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DB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B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DCD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7753948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kT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1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0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E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7580063"/>
                  </a:ext>
                </a:extLst>
              </a:tr>
              <a:tr h="17688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LK-1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EF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D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244" marR="9244" marT="92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3890053"/>
                  </a:ext>
                </a:extLst>
              </a:tr>
            </a:tbl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A9CADC78-5A51-44B5-87DC-FE5F2741374D}"/>
              </a:ext>
            </a:extLst>
          </p:cNvPr>
          <p:cNvSpPr txBox="1"/>
          <p:nvPr/>
        </p:nvSpPr>
        <p:spPr>
          <a:xfrm>
            <a:off x="5209697" y="328512"/>
            <a:ext cx="174249" cy="361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887554"/>
            <a:r>
              <a:rPr lang="en-US" sz="1747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33" name="Table 32">
            <a:extLst>
              <a:ext uri="{FF2B5EF4-FFF2-40B4-BE49-F238E27FC236}">
                <a16:creationId xmlns:a16="http://schemas.microsoft.com/office/drawing/2014/main" id="{D71D2BB6-7103-4DF4-A110-763963D982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9586843"/>
              </p:ext>
            </p:extLst>
          </p:nvPr>
        </p:nvGraphicFramePr>
        <p:xfrm>
          <a:off x="7156674" y="3273393"/>
          <a:ext cx="255498" cy="1104720"/>
        </p:xfrm>
        <a:graphic>
          <a:graphicData uri="http://schemas.openxmlformats.org/drawingml/2006/table">
            <a:tbl>
              <a:tblPr/>
              <a:tblGrid>
                <a:gridCol w="255498">
                  <a:extLst>
                    <a:ext uri="{9D8B030D-6E8A-4147-A177-3AD203B41FA5}">
                      <a16:colId xmlns:a16="http://schemas.microsoft.com/office/drawing/2014/main" val="1884288143"/>
                    </a:ext>
                  </a:extLst>
                </a:gridCol>
              </a:tblGrid>
              <a:tr h="167382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5</a:t>
                      </a:r>
                    </a:p>
                  </a:txBody>
                  <a:tcPr marL="9244" marR="9244" marT="92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102267"/>
                  </a:ext>
                </a:extLst>
              </a:tr>
              <a:tr h="167382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25</a:t>
                      </a:r>
                    </a:p>
                  </a:txBody>
                  <a:tcPr marL="9244" marR="9244" marT="92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7510517"/>
                  </a:ext>
                </a:extLst>
              </a:tr>
              <a:tr h="167382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25</a:t>
                      </a:r>
                    </a:p>
                  </a:txBody>
                  <a:tcPr marL="9244" marR="9244" marT="92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9716007"/>
                  </a:ext>
                </a:extLst>
              </a:tr>
              <a:tr h="167382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244" marR="9244" marT="92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836605"/>
                  </a:ext>
                </a:extLst>
              </a:tr>
              <a:tr h="167382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125</a:t>
                      </a:r>
                    </a:p>
                  </a:txBody>
                  <a:tcPr marL="9244" marR="9244" marT="92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BFB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2131775"/>
                  </a:ext>
                </a:extLst>
              </a:tr>
              <a:tr h="133905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25</a:t>
                      </a:r>
                    </a:p>
                  </a:txBody>
                  <a:tcPr marL="9244" marR="9244" marT="92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F7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7959204"/>
                  </a:ext>
                </a:extLst>
              </a:tr>
              <a:tr h="133905"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.5</a:t>
                      </a:r>
                    </a:p>
                  </a:txBody>
                  <a:tcPr marL="9244" marR="9244" marT="924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00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7315902"/>
                  </a:ext>
                </a:extLst>
              </a:tr>
            </a:tbl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C9D90872-A697-4D2B-ACA3-EF16497058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1575249"/>
              </p:ext>
            </p:extLst>
          </p:nvPr>
        </p:nvGraphicFramePr>
        <p:xfrm>
          <a:off x="590319" y="6150136"/>
          <a:ext cx="2027722" cy="35290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69" name="Prism 8" r:id="rId10" imgW="2195387" imgH="3820874" progId="Prism8.Document">
                  <p:embed/>
                </p:oleObj>
              </mc:Choice>
              <mc:Fallback>
                <p:oleObj name="Prism 8" r:id="rId10" imgW="2195387" imgH="382087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90319" y="6150136"/>
                        <a:ext cx="2027722" cy="35290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70727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Chart, diagram, bubble chart&#10;&#10;Description automatically generated">
            <a:extLst>
              <a:ext uri="{FF2B5EF4-FFF2-40B4-BE49-F238E27FC236}">
                <a16:creationId xmlns:a16="http://schemas.microsoft.com/office/drawing/2014/main" id="{BA01D547-BEC2-45D7-8F30-CEF1866CD9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15" y="1570616"/>
            <a:ext cx="7772400" cy="6918859"/>
          </a:xfrm>
          <a:prstGeom prst="rect">
            <a:avLst/>
          </a:prstGeom>
        </p:spPr>
      </p:pic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80EA22D2-D738-4F1A-B587-EBE8B0B47DBB}"/>
              </a:ext>
            </a:extLst>
          </p:cNvPr>
          <p:cNvSpPr/>
          <p:nvPr/>
        </p:nvSpPr>
        <p:spPr>
          <a:xfrm>
            <a:off x="839093" y="1568925"/>
            <a:ext cx="3067722" cy="3747140"/>
          </a:xfrm>
          <a:prstGeom prst="round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98681EB8-E480-4459-AC0C-523E60946201}"/>
              </a:ext>
            </a:extLst>
          </p:cNvPr>
          <p:cNvSpPr/>
          <p:nvPr/>
        </p:nvSpPr>
        <p:spPr>
          <a:xfrm>
            <a:off x="3906815" y="1570616"/>
            <a:ext cx="2364890" cy="3745448"/>
          </a:xfrm>
          <a:prstGeom prst="round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0BD00E92-A33B-41BA-B993-0FE3867FE89A}"/>
              </a:ext>
            </a:extLst>
          </p:cNvPr>
          <p:cNvSpPr/>
          <p:nvPr/>
        </p:nvSpPr>
        <p:spPr>
          <a:xfrm>
            <a:off x="968185" y="5497149"/>
            <a:ext cx="1968649" cy="2441995"/>
          </a:xfrm>
          <a:prstGeom prst="round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8CD1B2B1-45B7-4489-A866-B7801153C4B9}"/>
              </a:ext>
            </a:extLst>
          </p:cNvPr>
          <p:cNvSpPr/>
          <p:nvPr/>
        </p:nvSpPr>
        <p:spPr>
          <a:xfrm>
            <a:off x="5265418" y="5390480"/>
            <a:ext cx="1677296" cy="2441087"/>
          </a:xfrm>
          <a:prstGeom prst="roundRect">
            <a:avLst/>
          </a:prstGeom>
          <a:noFill/>
          <a:ln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FF9EC359-8C8F-45B1-8E2A-A85A3FAD476A}"/>
              </a:ext>
            </a:extLst>
          </p:cNvPr>
          <p:cNvSpPr/>
          <p:nvPr/>
        </p:nvSpPr>
        <p:spPr>
          <a:xfrm>
            <a:off x="3187847" y="5316064"/>
            <a:ext cx="1968648" cy="3171720"/>
          </a:xfrm>
          <a:prstGeom prst="round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0CFD52C-B1C3-42F5-8334-9FE10EB23F85}"/>
              </a:ext>
            </a:extLst>
          </p:cNvPr>
          <p:cNvSpPr txBox="1"/>
          <p:nvPr/>
        </p:nvSpPr>
        <p:spPr>
          <a:xfrm>
            <a:off x="1700271" y="1207661"/>
            <a:ext cx="1625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FN-I mediated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C37B209-8E15-44A5-B693-BB321EAAB58D}"/>
              </a:ext>
            </a:extLst>
          </p:cNvPr>
          <p:cNvSpPr txBox="1"/>
          <p:nvPr/>
        </p:nvSpPr>
        <p:spPr>
          <a:xfrm>
            <a:off x="1278862" y="8029643"/>
            <a:ext cx="15875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flammasom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A08412E-4488-4B59-A178-AC9BA86C6437}"/>
              </a:ext>
            </a:extLst>
          </p:cNvPr>
          <p:cNvSpPr txBox="1"/>
          <p:nvPr/>
        </p:nvSpPr>
        <p:spPr>
          <a:xfrm>
            <a:off x="4276281" y="1207661"/>
            <a:ext cx="1683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NF</a:t>
            </a:r>
            <a:r>
              <a:rPr lang="el-GR" dirty="0"/>
              <a:t>α</a:t>
            </a:r>
            <a:r>
              <a:rPr lang="en-US" dirty="0"/>
              <a:t> mediated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526FE42-1696-4199-8EE5-10120DB6F795}"/>
              </a:ext>
            </a:extLst>
          </p:cNvPr>
          <p:cNvSpPr txBox="1"/>
          <p:nvPr/>
        </p:nvSpPr>
        <p:spPr>
          <a:xfrm>
            <a:off x="5316756" y="8029643"/>
            <a:ext cx="154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53 mediated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EA175B-0F75-4705-801D-9666C46DF5B0}"/>
              </a:ext>
            </a:extLst>
          </p:cNvPr>
          <p:cNvSpPr txBox="1"/>
          <p:nvPr/>
        </p:nvSpPr>
        <p:spPr>
          <a:xfrm>
            <a:off x="497844" y="769575"/>
            <a:ext cx="174249" cy="3611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887554"/>
            <a:r>
              <a:rPr lang="en-US" sz="1747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812928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506</TotalTime>
  <Words>219</Words>
  <Application>Microsoft Office PowerPoint</Application>
  <PresentationFormat>Custom</PresentationFormat>
  <Paragraphs>195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gura, Jason (NIH/NIAID) [F]</dc:creator>
  <cp:lastModifiedBy>Sun, Peter (NIH/NIAID) [E]</cp:lastModifiedBy>
  <cp:revision>1889</cp:revision>
  <cp:lastPrinted>2022-11-29T16:07:58Z</cp:lastPrinted>
  <dcterms:created xsi:type="dcterms:W3CDTF">2018-11-20T18:59:25Z</dcterms:created>
  <dcterms:modified xsi:type="dcterms:W3CDTF">2023-01-20T16:01:33Z</dcterms:modified>
</cp:coreProperties>
</file>